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12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3146400"/>
              </p:ext>
            </p:extLst>
          </p:nvPr>
        </p:nvGraphicFramePr>
        <p:xfrm>
          <a:off x="1815454" y="990435"/>
          <a:ext cx="4891448" cy="3896189"/>
        </p:xfrm>
        <a:graphic>
          <a:graphicData uri="http://schemas.openxmlformats.org/drawingml/2006/table">
            <a:tbl>
              <a:tblPr/>
              <a:tblGrid>
                <a:gridCol w="1222862"/>
                <a:gridCol w="1222862"/>
                <a:gridCol w="1222862"/>
                <a:gridCol w="1222862"/>
              </a:tblGrid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ST-002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ST-003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nitinib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440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DA-MB-23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40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417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.4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T29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18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285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964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CI-H460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873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32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~ 2.758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ki-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03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983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13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86-O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35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559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127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549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57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169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85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LCPRF5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/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035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207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epa1-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/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69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197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703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637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7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068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l-7402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95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07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222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72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84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308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.95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UH-7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759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.314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219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k-hep-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463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37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17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16-F10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798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77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618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1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UVEC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635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512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117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文本框 3"/>
          <p:cNvSpPr txBox="1"/>
          <p:nvPr/>
        </p:nvSpPr>
        <p:spPr>
          <a:xfrm>
            <a:off x="539552" y="404664"/>
            <a:ext cx="67384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dirty="0" smtClean="0"/>
              <a:t>Supplementary Table 2</a:t>
            </a:r>
            <a:endParaRPr kumimoji="1"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45571516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0</TotalTime>
  <Words>93</Words>
  <Application>Microsoft Macintosh PowerPoint</Application>
  <PresentationFormat>全屏显示(4:3)</PresentationFormat>
  <Paragraphs>6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静脉给药Sample A 和Sunitinib后舒尼替尼在小鼠血浆及各脏器中分布的对比</dc:title>
  <dc:creator>Administrator</dc:creator>
  <cp:lastModifiedBy>apple</cp:lastModifiedBy>
  <cp:revision>36</cp:revision>
  <dcterms:created xsi:type="dcterms:W3CDTF">2015-04-30T18:18:05Z</dcterms:created>
  <dcterms:modified xsi:type="dcterms:W3CDTF">2015-10-14T04:56:50Z</dcterms:modified>
</cp:coreProperties>
</file>